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50" d="100"/>
          <a:sy n="50" d="100"/>
        </p:scale>
        <p:origin x="1133" y="7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B66B7CA-CA9E-6AB9-6753-C19C926664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082BE361-0E72-EAA2-38E9-310E1EC555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1736C47-7436-A97C-3E60-047D6DA87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F3C35-9740-4A12-A5BA-516F80E32B74}" type="datetimeFigureOut">
              <a:rPr lang="en-US" smtClean="0"/>
              <a:t>5/17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88F6181-B29F-4B7E-8E4C-2E656FE8A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163F91C-98FF-7FB3-9FC4-19FB84422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F391B-4D02-4B8D-9140-C7EE8B171A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148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04F004D-CF95-3E41-F545-6388401545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989D2A1-BA4D-1025-ADEB-AE1A3A9479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B274D06-A64C-C594-EB61-1FEECCB966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F3C35-9740-4A12-A5BA-516F80E32B74}" type="datetimeFigureOut">
              <a:rPr lang="en-US" smtClean="0"/>
              <a:t>5/17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AF91344-4BF9-2A35-0DD8-21ED056BE8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A80B6DF-413B-D106-5AB2-3AFAD6546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F391B-4D02-4B8D-9140-C7EE8B171A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472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C8AF890-F7A3-DDC6-F407-048481EA98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B2AA8B5-1AF1-6C82-10CB-499CF09673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77E4EB8-4057-1722-9118-6CCF96E671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F3C35-9740-4A12-A5BA-516F80E32B74}" type="datetimeFigureOut">
              <a:rPr lang="en-US" smtClean="0"/>
              <a:t>5/17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F9E6DD0-51AA-CF6D-0717-260D40244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DFEAADD-E45B-2C44-4025-E3C319A55F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F391B-4D02-4B8D-9140-C7EE8B171A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511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406820C-ED8D-0132-2A8D-F91A257958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2B6C419-291C-46ED-CCD2-E77AE2E1E8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1380BEF-BB6D-53A9-149B-0831C59D5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F3C35-9740-4A12-A5BA-516F80E32B74}" type="datetimeFigureOut">
              <a:rPr lang="en-US" smtClean="0"/>
              <a:t>5/17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CE88D1A-7E9F-DDA5-D0C2-9E6B0E85B9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BD7B461-3F2E-7721-0BFB-988A34DFE2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F391B-4D02-4B8D-9140-C7EE8B171A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986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80B8CA3-3774-C5FF-8DA4-F41752F5B4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532081B-8C2C-9BA6-EE06-5BF24B2E49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404C64D-5EC7-6805-8D18-20C5DA2FE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F3C35-9740-4A12-A5BA-516F80E32B74}" type="datetimeFigureOut">
              <a:rPr lang="en-US" smtClean="0"/>
              <a:t>5/17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7F378E7-A06E-3391-BDAD-DB329CF70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F15BBA3-D035-F1BA-BAE7-EDF32055B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F391B-4D02-4B8D-9140-C7EE8B171A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890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6307F46-75B9-D510-50BD-B9459A7975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4494FA5-6F61-486C-40C1-ABAECC74B5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9F08DDB-A0CF-3DA2-8C6D-89D60BDBDF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A54E8A9-1CB4-CF0C-6C65-036CAD1A93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F3C35-9740-4A12-A5BA-516F80E32B74}" type="datetimeFigureOut">
              <a:rPr lang="en-US" smtClean="0"/>
              <a:t>5/17/2023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52C887A-8918-A506-85C9-ACC839E44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0389908-AA4C-3C76-6388-8225B746F9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F391B-4D02-4B8D-9140-C7EE8B171A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225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EE16D86-C409-1760-B324-C21A499271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A65574D-6148-8532-4206-31AA38FAB6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170BA55-D02E-2ACE-9F88-FA52504224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024E89C8-0946-AC18-3114-2CFEEE5365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27D66CFD-B231-014D-7C08-82A33F9F1B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A35FC23A-9E79-DD78-995E-CD92A7115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F3C35-9740-4A12-A5BA-516F80E32B74}" type="datetimeFigureOut">
              <a:rPr lang="en-US" smtClean="0"/>
              <a:t>5/17/2023</a:t>
            </a:fld>
            <a:endParaRPr lang="en-US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F647915-42BD-EDC3-255C-381208F477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BE1BAF5-6D9D-3D6E-71A7-2D9502746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F391B-4D02-4B8D-9140-C7EE8B171A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57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7765745-2733-1FC1-4A6E-2E4C8AD9A1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B9E33D9C-B588-7816-268B-C2A5252F23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F3C35-9740-4A12-A5BA-516F80E32B74}" type="datetimeFigureOut">
              <a:rPr lang="en-US" smtClean="0"/>
              <a:t>5/17/2023</a:t>
            </a:fld>
            <a:endParaRPr lang="en-US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575EC27-4B3A-7260-D676-52E8798B3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87CF082-B010-F18C-2C2A-5E80190F0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F391B-4D02-4B8D-9140-C7EE8B171A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691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51D516A5-B67B-865D-8AC7-9D059BEF7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F3C35-9740-4A12-A5BA-516F80E32B74}" type="datetimeFigureOut">
              <a:rPr lang="en-US" smtClean="0"/>
              <a:t>5/17/2023</a:t>
            </a:fld>
            <a:endParaRPr lang="en-US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CADC8911-8BCF-F0F5-8078-5DCD142BAA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BFF94B8-76DA-4514-187D-04C0D607D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F391B-4D02-4B8D-9140-C7EE8B171A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129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82CB839-4722-377E-4361-4429BD2E1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A871ED7-B2B6-7A22-523C-0EA3629C4A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EAC5A1A-0792-CFBA-D6F6-AB18022F42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145D4E0-28B0-9925-4763-D4B37B4B17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F3C35-9740-4A12-A5BA-516F80E32B74}" type="datetimeFigureOut">
              <a:rPr lang="en-US" smtClean="0"/>
              <a:t>5/17/2023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98B3EDD-A4B8-188F-CD84-F0ABE1C65D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595FD42-C9DE-96B3-E4BA-E98B2D943D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F391B-4D02-4B8D-9140-C7EE8B171A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773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83E469-ED30-65BE-7ADD-DB91DE6AFF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80F9E99-F61C-A5DD-EA7B-47AC3EBA593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25F1D54-91FB-DED3-97E0-C47AED7182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42B28FA-35B8-A765-86C1-0361664E9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F3C35-9740-4A12-A5BA-516F80E32B74}" type="datetimeFigureOut">
              <a:rPr lang="en-US" smtClean="0"/>
              <a:t>5/17/2023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0BBA4C1-94AC-E0F2-4C28-8A58679966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F9E0741-7574-C939-04CB-1F82F2793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F391B-4D02-4B8D-9140-C7EE8B171A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22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003F6868-1C91-D7F5-030C-77F624C057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42B4645-2E0F-E991-4191-3C21E1A839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EC6E5D0-66FC-33EB-A738-2958141251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8F3C35-9740-4A12-A5BA-516F80E32B74}" type="datetimeFigureOut">
              <a:rPr lang="en-US" smtClean="0"/>
              <a:t>5/17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97052A8-7913-91E3-0ADB-4D82BFCEBB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244723A-D2EB-D678-3B57-361A4D5743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AF391B-4D02-4B8D-9140-C7EE8B171A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5779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E04D7B65-838D-6C9A-2AA3-BEDA7C60627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52" t="-703" r="-1206" b="-3626"/>
          <a:stretch/>
        </p:blipFill>
        <p:spPr bwMode="auto">
          <a:xfrm>
            <a:off x="2084413" y="1531620"/>
            <a:ext cx="7524536" cy="3086100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CCF843CC-AABC-4634-8C26-A818F93DD757}"/>
              </a:ext>
            </a:extLst>
          </p:cNvPr>
          <p:cNvSpPr txBox="1"/>
          <p:nvPr/>
        </p:nvSpPr>
        <p:spPr>
          <a:xfrm>
            <a:off x="944880" y="838200"/>
            <a:ext cx="78965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Upper </a:t>
            </a:r>
            <a:r>
              <a:rPr lang="de-DE" dirty="0" err="1"/>
              <a:t>panel</a:t>
            </a:r>
            <a:r>
              <a:rPr lang="de-DE" dirty="0"/>
              <a:t> of </a:t>
            </a:r>
            <a:r>
              <a:rPr lang="de-DE" dirty="0" err="1"/>
              <a:t>Supplemental</a:t>
            </a:r>
            <a:r>
              <a:rPr lang="de-DE" dirty="0"/>
              <a:t> Figure S5C, </a:t>
            </a:r>
            <a:r>
              <a:rPr lang="de-DE" dirty="0" err="1"/>
              <a:t>blot</a:t>
            </a:r>
            <a:r>
              <a:rPr lang="de-DE" dirty="0"/>
              <a:t> </a:t>
            </a:r>
            <a:r>
              <a:rPr lang="de-DE" dirty="0" err="1"/>
              <a:t>detected</a:t>
            </a:r>
            <a:r>
              <a:rPr lang="de-DE" dirty="0"/>
              <a:t> with </a:t>
            </a:r>
            <a:r>
              <a:rPr lang="de-DE" dirty="0" err="1"/>
              <a:t>antibody</a:t>
            </a:r>
            <a:r>
              <a:rPr lang="de-DE" dirty="0"/>
              <a:t> against VIPP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037095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>
            <a:extLst>
              <a:ext uri="{FF2B5EF4-FFF2-40B4-BE49-F238E27FC236}">
                <a16:creationId xmlns:a16="http://schemas.microsoft.com/office/drawing/2014/main" id="{2A85DDC4-ECA7-BD79-AF42-36EBFBC11DA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5" t="-1094" r="-260" b="63764"/>
          <a:stretch/>
        </p:blipFill>
        <p:spPr bwMode="auto">
          <a:xfrm>
            <a:off x="228780" y="2343150"/>
            <a:ext cx="11734440" cy="2781300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1F2FFC44-7E9D-991E-7868-6B948C8973B0}"/>
              </a:ext>
            </a:extLst>
          </p:cNvPr>
          <p:cNvSpPr txBox="1"/>
          <p:nvPr/>
        </p:nvSpPr>
        <p:spPr>
          <a:xfrm>
            <a:off x="944880" y="838200"/>
            <a:ext cx="7914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Lower </a:t>
            </a:r>
            <a:r>
              <a:rPr lang="de-DE" dirty="0" err="1"/>
              <a:t>panel</a:t>
            </a:r>
            <a:r>
              <a:rPr lang="de-DE" dirty="0"/>
              <a:t> of </a:t>
            </a:r>
            <a:r>
              <a:rPr lang="de-DE" dirty="0" err="1"/>
              <a:t>Supplemental</a:t>
            </a:r>
            <a:r>
              <a:rPr lang="de-DE" dirty="0"/>
              <a:t> Figure S5C, </a:t>
            </a:r>
            <a:r>
              <a:rPr lang="de-DE" dirty="0" err="1"/>
              <a:t>blot</a:t>
            </a:r>
            <a:r>
              <a:rPr lang="de-DE" dirty="0"/>
              <a:t> </a:t>
            </a:r>
            <a:r>
              <a:rPr lang="de-DE" dirty="0" err="1"/>
              <a:t>detected</a:t>
            </a:r>
            <a:r>
              <a:rPr lang="de-DE" dirty="0"/>
              <a:t> with </a:t>
            </a:r>
            <a:r>
              <a:rPr lang="de-DE" dirty="0" err="1"/>
              <a:t>antibody</a:t>
            </a:r>
            <a:r>
              <a:rPr lang="de-DE" dirty="0"/>
              <a:t> against </a:t>
            </a:r>
            <a:r>
              <a:rPr lang="de-DE" dirty="0" err="1"/>
              <a:t>BirA</a:t>
            </a:r>
            <a:r>
              <a:rPr lang="de-DE" dirty="0"/>
              <a:t>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9078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Breitbild</PresentationFormat>
  <Paragraphs>2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hael Schroda</dc:creator>
  <cp:lastModifiedBy>Michael Schroda</cp:lastModifiedBy>
  <cp:revision>1</cp:revision>
  <dcterms:created xsi:type="dcterms:W3CDTF">2023-05-17T06:01:14Z</dcterms:created>
  <dcterms:modified xsi:type="dcterms:W3CDTF">2023-05-17T12:56:54Z</dcterms:modified>
</cp:coreProperties>
</file>